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71" d="100"/>
          <a:sy n="71" d="100"/>
        </p:scale>
        <p:origin x="-100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68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670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19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226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232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733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289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692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253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53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876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6E26B-2C17-1447-8000-995591A62767}" type="datetimeFigureOut">
              <a:rPr lang="en-US" smtClean="0"/>
              <a:t>04.05.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39157E-33A2-474C-8B36-B6929D064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00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1510" y="1729415"/>
            <a:ext cx="3635403" cy="37351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8526" y="1729415"/>
            <a:ext cx="3852984" cy="373512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0" y="50991"/>
            <a:ext cx="488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-figure supplement 1-Source data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0" y="618996"/>
            <a:ext cx="488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-figure supplement 1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611857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3808" y="1506015"/>
            <a:ext cx="2663777" cy="415235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27585" y="1580637"/>
            <a:ext cx="3058302" cy="407773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92800" y="1213229"/>
            <a:ext cx="3251200" cy="46228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0" y="50991"/>
            <a:ext cx="488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-figure supplement 1-Source data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677333" y="4835407"/>
            <a:ext cx="2032000" cy="705555"/>
          </a:xfrm>
          <a:prstGeom prst="rect">
            <a:avLst/>
          </a:prstGeom>
          <a:noFill/>
          <a:ln w="28575" cmpd="sng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045177" y="1714029"/>
            <a:ext cx="2032000" cy="705555"/>
          </a:xfrm>
          <a:prstGeom prst="rect">
            <a:avLst/>
          </a:prstGeom>
          <a:noFill/>
          <a:ln w="28575" cmpd="sng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6485466" y="2267186"/>
            <a:ext cx="2305756" cy="852308"/>
          </a:xfrm>
          <a:prstGeom prst="rect">
            <a:avLst/>
          </a:prstGeom>
          <a:noFill/>
          <a:ln w="28575" cmpd="sng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06860" y="6055184"/>
            <a:ext cx="1304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4EBP1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359371" y="6055184"/>
            <a:ext cx="1304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eIF4G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841994" y="6055184"/>
            <a:ext cx="1304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eIF4B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63808" y="1136683"/>
            <a:ext cx="488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-figure supplement 1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631447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592" y="1148941"/>
            <a:ext cx="8623300" cy="50419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77333" y="3630255"/>
            <a:ext cx="2032000" cy="70555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397955" y="3613320"/>
            <a:ext cx="2204156" cy="70555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022621" y="3260542"/>
            <a:ext cx="2218267" cy="70555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906860" y="6374032"/>
            <a:ext cx="1304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4EBP1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613371" y="6340362"/>
            <a:ext cx="1304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eIF4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841994" y="6374032"/>
            <a:ext cx="1304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eIF4B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0" y="50991"/>
            <a:ext cx="488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-figure supplement 1-Source data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0" y="779609"/>
            <a:ext cx="488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-figure supplement 2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886210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1</Words>
  <Application>Microsoft Macintosh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triz Alvarez-Castelao</dc:creator>
  <cp:lastModifiedBy>Beatriz Alvarez-Castelao</cp:lastModifiedBy>
  <cp:revision>1</cp:revision>
  <dcterms:created xsi:type="dcterms:W3CDTF">2020-05-04T12:39:56Z</dcterms:created>
  <dcterms:modified xsi:type="dcterms:W3CDTF">2020-05-04T15:33:49Z</dcterms:modified>
</cp:coreProperties>
</file>